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72" d="100"/>
          <a:sy n="72" d="100"/>
        </p:scale>
        <p:origin x="57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738BFD-4EA8-4F91-8331-BA2B6307C4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839F4D4-B2F1-4FE0-94BF-606D0B110F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AC3626-F069-475A-B95E-CAE97075F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5A884A-0A3F-4959-9A86-77A89F9A0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A16DA4-C9DD-458C-9A99-D74D022D0F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095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B71800-2186-4010-824C-E7E5137CE8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8B7A1D-F1BA-44E6-A0F7-BBFBCA6148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C485AB-00E4-487D-A0F2-06EAA58514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A4ACD2-3C16-4513-92F7-46B35C8F90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712DF0-E06E-4B48-AFE4-E78CCF7B3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074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C870EEB-589C-4EBC-8C7D-C68F40EE10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003FA7-9829-4B67-8C20-AE17FC4082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BAA306-3B1F-4B0D-A282-8A405F379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6A8E88-016E-40FC-9357-E5C2343B49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3AF610-FE2A-4D8F-9D53-D1E0ACF4A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4354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C651C5-B0EB-4101-8063-C039BB0A75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2C4A16-1BB9-4EF4-8463-594B0C1932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9D0242-F931-4DBE-AF4D-4623524C7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308A1C-0B34-49DF-996B-E9E1670610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635ECD-43B9-474C-A6BD-31971D240F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557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134E12-8901-404C-B4BF-12BA0EE097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DE9CFC-E197-43FF-86B4-DD0132F015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35AB15-17B6-4051-B657-681CD998A4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48D906-DC0A-469D-B6D2-03BFF024E7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D42B54-2481-4911-A68C-626956FCF9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455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6AE251-60C2-41F9-AE78-2804BA13C6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8B24B8-C4EF-4BEA-8059-A08AE21C59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34F73B-E991-4C9A-8E60-736FA7DE97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AE10BF-2BEB-434C-90BE-143B38D3B1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8A0FB2-E111-496E-84AD-D39FC2FAB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6EA14F-6A6B-4C4A-ADBC-11AB0AB075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498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8A45E0-10FA-4168-A3D6-53FD58A6F2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8EB8C2-531C-45FE-BD05-C316145C9C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9B4E7A-5864-4BFE-9486-B64A79DC62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FD5FC2-25DA-4C31-99A4-381A355F72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EF9E05F-638E-4276-BCB7-2A2DFA261A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275624D-9CB3-4598-A507-F9EE11177D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0ED3666-0ED6-41E3-A294-3980695F9E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EA5C41-96A9-482E-9822-D374850D21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3714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1776B7-3ACF-44BB-AB2C-0DB7799790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06B6F9-9AD7-4B24-8E9A-923F5BB2A4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D71F4DF-0194-40BB-9211-D76EC2305C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52ED4BA-81F2-463D-AF8D-577A889D07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1188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E01622D-45CA-4646-B24C-F9B204A136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E7FCC27-C0CC-4714-9AAF-B6AC0A237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456D23-BAF4-47CE-BBF2-5F7B039CF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550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A8A7DD-5094-4A37-BC70-CB11787D70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0796B0-FFA5-4342-B5E6-82E0908BC9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C7D5014-E228-48E0-8C87-582C9031CF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7995D6-281A-4391-A04A-8F5B3E9DB4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66A425-D815-4E18-BF93-C3D6C9F854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44D21D-87FC-4203-9F6A-3FA7BD6F6C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332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FAB79C-F9D3-4BF9-973E-9BCCC0D337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FEC63A6-DB6D-4A56-86ED-68EF7F8A8D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97BC94-0714-4D89-801E-B2A2DE83F8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7EA56F-BD7B-4842-B6BB-289503643E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34CAC1-0C90-4D1A-A84E-19FF1D583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9ABB3C-201B-4A3B-BBCE-C41B8A1E7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808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643502-FFF4-4382-9092-C5046CC4B4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8877AC-E817-4ACA-B5D4-6DE0E9CAFE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B0E90F-6B68-4FFD-A94D-E4540DCBF4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91D560-D7B3-4588-9672-179885302DC3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ABBD75-22B4-4409-8CE1-EF4E76FC1E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CE1DE-4510-4B9A-905B-0E07CFF342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81591E-CD37-4C41-8A3C-80E30A868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460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58B9F93-4656-4897-B38A-882220C609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1761565"/>
            <a:ext cx="2292534" cy="229701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1615554-34D2-4EB4-B819-D5C41F0384B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42013" y="1761565"/>
            <a:ext cx="2292535" cy="229732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B85BDD0-3837-4B90-BC36-D0C7C4100729}"/>
              </a:ext>
            </a:extLst>
          </p:cNvPr>
          <p:cNvSpPr txBox="1"/>
          <p:nvPr/>
        </p:nvSpPr>
        <p:spPr>
          <a:xfrm>
            <a:off x="2550326" y="1663500"/>
            <a:ext cx="38277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4266F80-1D9A-4451-8ED7-59194BCEEC7E}"/>
              </a:ext>
            </a:extLst>
          </p:cNvPr>
          <p:cNvSpPr txBox="1"/>
          <p:nvPr/>
        </p:nvSpPr>
        <p:spPr>
          <a:xfrm>
            <a:off x="5713228" y="1663500"/>
            <a:ext cx="38277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76CFAC2-28E9-415F-9D32-A6BEAFEB0F2A}"/>
              </a:ext>
            </a:extLst>
          </p:cNvPr>
          <p:cNvCxnSpPr>
            <a:cxnSpLocks/>
          </p:cNvCxnSpPr>
          <p:nvPr/>
        </p:nvCxnSpPr>
        <p:spPr>
          <a:xfrm flipH="1" flipV="1">
            <a:off x="4584759" y="3882935"/>
            <a:ext cx="338328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9C80E950-C4B6-4DDA-B4AD-987CA15A904F}"/>
              </a:ext>
            </a:extLst>
          </p:cNvPr>
          <p:cNvCxnSpPr>
            <a:cxnSpLocks/>
          </p:cNvCxnSpPr>
          <p:nvPr/>
        </p:nvCxnSpPr>
        <p:spPr>
          <a:xfrm flipH="1" flipV="1">
            <a:off x="7742297" y="3880554"/>
            <a:ext cx="338328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9B411712-9F2B-4873-9100-C37658D14A15}"/>
              </a:ext>
            </a:extLst>
          </p:cNvPr>
          <p:cNvSpPr txBox="1"/>
          <p:nvPr/>
        </p:nvSpPr>
        <p:spPr>
          <a:xfrm>
            <a:off x="871760" y="4504809"/>
            <a:ext cx="900029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600"/>
              </a:spcAft>
            </a:pPr>
            <a:r>
              <a:rPr lang="en-US" b="1" i="1" dirty="0">
                <a:latin typeface="Times New Roman" panose="02020603050405020304" pitchFamily="18" charset="0"/>
                <a:ea typeface="Batang" panose="02030600000101010101" pitchFamily="18" charset="-127"/>
              </a:rPr>
              <a:t>Figure S2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Batang" panose="02030600000101010101" pitchFamily="18" charset="-127"/>
              </a:rPr>
              <a:t>. Kidney and liver sections of rats treated with C153-RhoB-MLV nanoparticles.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Batang" panose="02030600000101010101" pitchFamily="18" charset="-127"/>
              </a:rPr>
              <a:t> Representative images of kidney (A) and liver (B) sections from rat tissue </a:t>
            </a:r>
            <a:r>
              <a:rPr lang="en-US" i="1" dirty="0">
                <a:latin typeface="Times New Roman" panose="02020603050405020304" pitchFamily="18" charset="0"/>
                <a:ea typeface="Batang" panose="02030600000101010101" pitchFamily="18" charset="-127"/>
              </a:rPr>
              <a:t>5 h post-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Batang" panose="02030600000101010101" pitchFamily="18" charset="-127"/>
              </a:rPr>
              <a:t>CCI</a:t>
            </a:r>
            <a:r>
              <a:rPr lang="en-US" i="1" dirty="0">
                <a:latin typeface="Times New Roman" panose="02020603050405020304" pitchFamily="18" charset="0"/>
                <a:ea typeface="Batang" panose="02030600000101010101" pitchFamily="18" charset="-127"/>
              </a:rPr>
              <a:t> after treatment with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Batang" panose="02030600000101010101" pitchFamily="18" charset="-127"/>
              </a:rPr>
              <a:t> C153-RhoB-MLV particles at 1 h and 4 h post-injury. No specific fluorescent signals were observed due to C153-RhoB-MLV. Scale bar = 50 </a:t>
            </a:r>
            <a:r>
              <a:rPr lang="el-GR" sz="1800" i="1" dirty="0">
                <a:effectLst/>
                <a:latin typeface="Times New Roman" panose="02020603050405020304" pitchFamily="18" charset="0"/>
                <a:ea typeface="Batang" panose="02030600000101010101" pitchFamily="18" charset="-127"/>
              </a:rPr>
              <a:t>μ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Batang" panose="02030600000101010101" pitchFamily="18" charset="-127"/>
              </a:rPr>
              <a:t>m.</a:t>
            </a:r>
            <a:endParaRPr lang="en-US" sz="1800" dirty="0">
              <a:effectLst/>
              <a:latin typeface="Times New Roman" panose="02020603050405020304" pitchFamily="18" charset="0"/>
              <a:ea typeface="Batang" panose="02030600000101010101" pitchFamily="18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40937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068</TotalTime>
  <Words>65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cky Whitener</dc:creator>
  <cp:lastModifiedBy>Jesus Diaz de Leon</cp:lastModifiedBy>
  <cp:revision>68</cp:revision>
  <dcterms:created xsi:type="dcterms:W3CDTF">2021-07-09T21:43:09Z</dcterms:created>
  <dcterms:modified xsi:type="dcterms:W3CDTF">2022-01-31T23:16:15Z</dcterms:modified>
</cp:coreProperties>
</file>